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6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1512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1241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4600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8248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1243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752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9690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4417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301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43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4976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6635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DBCA76-76E5-4E00-839D-280014E7D16B}" type="datetimeFigureOut">
              <a:rPr lang="ko-KR" altLang="en-US" smtClean="0"/>
              <a:t>2018-05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B66FC-52E3-42F7-8725-08701237CB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9820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표 5"/>
          <p:cNvGraphicFramePr>
            <a:graphicFrameLocks noGrp="1"/>
          </p:cNvGraphicFramePr>
          <p:nvPr>
            <p:extLst/>
          </p:nvPr>
        </p:nvGraphicFramePr>
        <p:xfrm>
          <a:off x="1186889" y="2046692"/>
          <a:ext cx="5707379" cy="1752600"/>
        </p:xfrm>
        <a:graphic>
          <a:graphicData uri="http://schemas.openxmlformats.org/drawingml/2006/table">
            <a:tbl>
              <a:tblPr firstRow="1" lastRow="1" bandRow="1"/>
              <a:tblGrid>
                <a:gridCol w="1437785">
                  <a:extLst>
                    <a:ext uri="{9D8B030D-6E8A-4147-A177-3AD203B41FA5}">
                      <a16:colId xmlns:a16="http://schemas.microsoft.com/office/drawing/2014/main" val="2542007243"/>
                    </a:ext>
                  </a:extLst>
                </a:gridCol>
                <a:gridCol w="709062">
                  <a:extLst>
                    <a:ext uri="{9D8B030D-6E8A-4147-A177-3AD203B41FA5}">
                      <a16:colId xmlns:a16="http://schemas.microsoft.com/office/drawing/2014/main" val="2133334014"/>
                    </a:ext>
                  </a:extLst>
                </a:gridCol>
                <a:gridCol w="709696">
                  <a:extLst>
                    <a:ext uri="{9D8B030D-6E8A-4147-A177-3AD203B41FA5}">
                      <a16:colId xmlns:a16="http://schemas.microsoft.com/office/drawing/2014/main" val="2812194338"/>
                    </a:ext>
                  </a:extLst>
                </a:gridCol>
                <a:gridCol w="709696">
                  <a:extLst>
                    <a:ext uri="{9D8B030D-6E8A-4147-A177-3AD203B41FA5}">
                      <a16:colId xmlns:a16="http://schemas.microsoft.com/office/drawing/2014/main" val="765244991"/>
                    </a:ext>
                  </a:extLst>
                </a:gridCol>
                <a:gridCol w="709062">
                  <a:extLst>
                    <a:ext uri="{9D8B030D-6E8A-4147-A177-3AD203B41FA5}">
                      <a16:colId xmlns:a16="http://schemas.microsoft.com/office/drawing/2014/main" val="3822125610"/>
                    </a:ext>
                  </a:extLst>
                </a:gridCol>
                <a:gridCol w="716039">
                  <a:extLst>
                    <a:ext uri="{9D8B030D-6E8A-4147-A177-3AD203B41FA5}">
                      <a16:colId xmlns:a16="http://schemas.microsoft.com/office/drawing/2014/main" val="694441051"/>
                    </a:ext>
                  </a:extLst>
                </a:gridCol>
                <a:gridCol w="716039">
                  <a:extLst>
                    <a:ext uri="{9D8B030D-6E8A-4147-A177-3AD203B41FA5}">
                      <a16:colId xmlns:a16="http://schemas.microsoft.com/office/drawing/2014/main" val="3294161903"/>
                    </a:ext>
                  </a:extLst>
                </a:gridCol>
              </a:tblGrid>
              <a:tr h="292100">
                <a:tc rowSpan="2">
                  <a:txBody>
                    <a:bodyPr/>
                    <a:lstStyle/>
                    <a:p>
                      <a:pPr algn="l"/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hIgG1-Fc-9Arg/pAcGFP-N1 (w/w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6773206"/>
                  </a:ext>
                </a:extLst>
              </a:tr>
              <a:tr h="2921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/1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20/1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0/1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80/1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100/1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200/1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4399999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pAcGFP-N1 </a:t>
                      </a:r>
                      <a:r>
                        <a:rPr lang="en-US" sz="1200" b="1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b="1" kern="100" dirty="0" err="1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ul</a:t>
                      </a: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)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811196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hIgG1-Fc-9Arg (</a:t>
                      </a:r>
                      <a:r>
                        <a:rPr lang="en-US" sz="1200" b="1" kern="100" dirty="0" err="1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ul</a:t>
                      </a: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)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2.77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11.11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27.77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44.44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55.55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111.1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3574241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PBS (ul)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192.23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183.89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167.23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150.56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139.45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83.90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16853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Total volume</a:t>
                      </a:r>
                      <a:endParaRPr lang="ko-KR" sz="1000" kern="10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effectLst/>
                          <a:latin typeface="Times New Roman" panose="02020603050405020304" pitchFamily="18" charset="0"/>
                          <a:ea typeface="휴먼명조" panose="02010504000101010101"/>
                          <a:cs typeface="Times New Roman" panose="02020603050405020304" pitchFamily="18" charset="0"/>
                        </a:rPr>
                        <a:t>200ul</a:t>
                      </a: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287408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66941" y="1173868"/>
            <a:ext cx="1710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ko-KR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66941" y="478692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 S. </a:t>
            </a:r>
            <a:r>
              <a:rPr lang="en-US" altLang="ko-K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endParaRPr lang="ko-KR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0426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51</Words>
  <Application>Microsoft Office PowerPoint</Application>
  <PresentationFormat>화면 슬라이드 쇼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휴먼명조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ngpil Cho</dc:creator>
  <cp:lastModifiedBy>Sungpil Cho</cp:lastModifiedBy>
  <cp:revision>4</cp:revision>
  <dcterms:created xsi:type="dcterms:W3CDTF">2018-05-17T05:52:04Z</dcterms:created>
  <dcterms:modified xsi:type="dcterms:W3CDTF">2018-05-21T09:08:25Z</dcterms:modified>
</cp:coreProperties>
</file>